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57" r:id="rId2"/>
    <p:sldId id="258" r:id="rId3"/>
    <p:sldId id="262" r:id="rId4"/>
    <p:sldId id="263" r:id="rId5"/>
    <p:sldId id="264" r:id="rId6"/>
    <p:sldId id="265" r:id="rId7"/>
    <p:sldId id="272" r:id="rId8"/>
    <p:sldId id="266" r:id="rId9"/>
    <p:sldId id="267" r:id="rId10"/>
    <p:sldId id="268" r:id="rId11"/>
    <p:sldId id="269" r:id="rId12"/>
    <p:sldId id="270" r:id="rId13"/>
    <p:sldId id="260" r:id="rId14"/>
    <p:sldId id="261" r:id="rId1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80F692-C530-4BFD-A11F-FB91E8FFD632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0C26A5-2E69-471B-8E33-DDA2B8231B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179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0C26A5-2E69-471B-8E33-DDA2B8231BB3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157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tiff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5" Type="http://schemas.openxmlformats.org/officeDocument/2006/relationships/image" Target="../media/image17.tiff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shaopo\Desktop\PIAS NP作图\DK-PIAS2-HA与NP互作\DK-PIAS2与212NP互作，第二次留图\123MIX1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967894"/>
            <a:ext cx="7507795" cy="3455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241557" y="5777752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A antibody</a:t>
            </a:r>
            <a:r>
              <a:rPr lang="zh-CN" altLang="en-US" sz="1200" dirty="0"/>
              <a:t>（</a:t>
            </a:r>
            <a:r>
              <a:rPr lang="en-US" altLang="zh-CN" sz="1200" dirty="0"/>
              <a:t>Rabbit</a:t>
            </a:r>
            <a:r>
              <a:rPr lang="zh-CN" altLang="en-US" sz="1200" dirty="0"/>
              <a:t>）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49351" y="4265674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NP antibody</a:t>
            </a:r>
            <a:r>
              <a:rPr lang="zh-CN" altLang="en-US" sz="1200" dirty="0"/>
              <a:t>（</a:t>
            </a:r>
            <a:r>
              <a:rPr lang="en-US" altLang="zh-CN" sz="1200" dirty="0"/>
              <a:t>Mouse</a:t>
            </a:r>
            <a:r>
              <a:rPr lang="zh-CN" altLang="en-US" sz="1200" dirty="0"/>
              <a:t>）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79512" y="4394548"/>
            <a:ext cx="936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HA Agarose bead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580639" y="4302215"/>
            <a:ext cx="129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Flag Agarose bead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cxnSp>
        <p:nvCxnSpPr>
          <p:cNvPr id="11" name="直接箭头连接符 10"/>
          <p:cNvCxnSpPr/>
          <p:nvPr/>
        </p:nvCxnSpPr>
        <p:spPr>
          <a:xfrm flipV="1">
            <a:off x="1043608" y="4227299"/>
            <a:ext cx="216024" cy="30574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1043608" y="4762876"/>
            <a:ext cx="217943" cy="164224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 flipH="1" flipV="1">
            <a:off x="8548288" y="4173878"/>
            <a:ext cx="197061" cy="164342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8533680" y="4737630"/>
            <a:ext cx="311842" cy="18947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2144924">
            <a:off x="1722429" y="2024708"/>
            <a:ext cx="461665" cy="100811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NP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12144924">
            <a:off x="2252473" y="1615794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PCAGGS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12144924">
            <a:off x="2762111" y="1499643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NP+PCAGGS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 rot="12144924">
            <a:off x="3511928" y="2109532"/>
            <a:ext cx="461665" cy="100811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NP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 rot="12144924">
            <a:off x="4041972" y="1572046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PCAGGS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 rot="12144924">
            <a:off x="4551610" y="1584467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NP+PCAGGS</a:t>
            </a:r>
            <a:endParaRPr lang="zh-CN" altLang="en-US" dirty="0"/>
          </a:p>
        </p:txBody>
      </p:sp>
      <p:sp>
        <p:nvSpPr>
          <p:cNvPr id="29" name="TextBox 28"/>
          <p:cNvSpPr txBox="1"/>
          <p:nvPr/>
        </p:nvSpPr>
        <p:spPr>
          <a:xfrm rot="12144924">
            <a:off x="5322830" y="2177108"/>
            <a:ext cx="461665" cy="100811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NP</a:t>
            </a:r>
            <a:endParaRPr lang="zh-CN" altLang="en-US" dirty="0"/>
          </a:p>
        </p:txBody>
      </p:sp>
      <p:sp>
        <p:nvSpPr>
          <p:cNvPr id="30" name="TextBox 29"/>
          <p:cNvSpPr txBox="1"/>
          <p:nvPr/>
        </p:nvSpPr>
        <p:spPr>
          <a:xfrm rot="12144924">
            <a:off x="5852874" y="1639622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PCAGGS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 rot="12144924">
            <a:off x="6362512" y="1652043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NP+PCAGGS</a:t>
            </a:r>
            <a:endParaRPr lang="zh-CN" altLang="en-US" dirty="0"/>
          </a:p>
        </p:txBody>
      </p:sp>
      <p:sp>
        <p:nvSpPr>
          <p:cNvPr id="32" name="TextBox 31"/>
          <p:cNvSpPr txBox="1"/>
          <p:nvPr/>
        </p:nvSpPr>
        <p:spPr>
          <a:xfrm rot="12144924">
            <a:off x="7195038" y="2181540"/>
            <a:ext cx="461665" cy="100811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NP</a:t>
            </a:r>
            <a:endParaRPr lang="zh-CN" altLang="en-US" dirty="0"/>
          </a:p>
        </p:txBody>
      </p:sp>
      <p:sp>
        <p:nvSpPr>
          <p:cNvPr id="33" name="TextBox 32"/>
          <p:cNvSpPr txBox="1"/>
          <p:nvPr/>
        </p:nvSpPr>
        <p:spPr>
          <a:xfrm rot="12144924">
            <a:off x="7725082" y="1644054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PIAS2+PCAGGS</a:t>
            </a:r>
            <a:endParaRPr lang="zh-CN" altLang="en-US" dirty="0"/>
          </a:p>
        </p:txBody>
      </p:sp>
      <p:sp>
        <p:nvSpPr>
          <p:cNvPr id="34" name="TextBox 33"/>
          <p:cNvSpPr txBox="1"/>
          <p:nvPr/>
        </p:nvSpPr>
        <p:spPr>
          <a:xfrm rot="12144924">
            <a:off x="8234720" y="1656475"/>
            <a:ext cx="461665" cy="1553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NP+PCAGGS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3136269" y="1627153"/>
            <a:ext cx="1730441" cy="5172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3337162" y="6423620"/>
            <a:ext cx="1294582" cy="375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Inpu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6876256" y="1627153"/>
            <a:ext cx="1730441" cy="5172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TextBox 37"/>
          <p:cNvSpPr txBox="1"/>
          <p:nvPr/>
        </p:nvSpPr>
        <p:spPr>
          <a:xfrm>
            <a:off x="7092280" y="6430461"/>
            <a:ext cx="1294582" cy="375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Inpu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1401399" y="1627153"/>
            <a:ext cx="1730441" cy="5172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TextBox 39"/>
          <p:cNvSpPr txBox="1"/>
          <p:nvPr/>
        </p:nvSpPr>
        <p:spPr>
          <a:xfrm>
            <a:off x="1619328" y="6420413"/>
            <a:ext cx="1294582" cy="375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IP-HA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5076056" y="1587800"/>
            <a:ext cx="1730441" cy="5172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TextBox 41"/>
          <p:cNvSpPr txBox="1"/>
          <p:nvPr/>
        </p:nvSpPr>
        <p:spPr>
          <a:xfrm>
            <a:off x="5436415" y="6423620"/>
            <a:ext cx="1294582" cy="375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971600" y="4018676"/>
            <a:ext cx="57572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79512" y="3894921"/>
            <a:ext cx="8476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High-chain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55KD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cxnSp>
        <p:nvCxnSpPr>
          <p:cNvPr id="48" name="直接箭头连接符 47"/>
          <p:cNvCxnSpPr/>
          <p:nvPr/>
        </p:nvCxnSpPr>
        <p:spPr>
          <a:xfrm>
            <a:off x="969772" y="3774972"/>
            <a:ext cx="57572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07504" y="363647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NP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58KD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85447" y="4999108"/>
            <a:ext cx="936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PIAS2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62KD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cxnSp>
        <p:nvCxnSpPr>
          <p:cNvPr id="51" name="直接箭头连接符 50"/>
          <p:cNvCxnSpPr/>
          <p:nvPr/>
        </p:nvCxnSpPr>
        <p:spPr>
          <a:xfrm>
            <a:off x="821156" y="5215132"/>
            <a:ext cx="57572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2185980" y="4279574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NP antibody</a:t>
            </a:r>
            <a:r>
              <a:rPr lang="zh-CN" altLang="en-US" sz="1200" dirty="0"/>
              <a:t>（</a:t>
            </a:r>
            <a:r>
              <a:rPr lang="en-US" altLang="zh-CN" sz="1200" dirty="0"/>
              <a:t>Mouse</a:t>
            </a:r>
            <a:r>
              <a:rPr lang="zh-CN" altLang="en-US" sz="1200" dirty="0"/>
              <a:t>）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940152" y="5801916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A antibody</a:t>
            </a:r>
            <a:r>
              <a:rPr lang="zh-CN" altLang="en-US" sz="1200" dirty="0"/>
              <a:t>（</a:t>
            </a:r>
            <a:r>
              <a:rPr lang="en-US" altLang="zh-CN" sz="1200" dirty="0"/>
              <a:t>Rabbit</a:t>
            </a:r>
            <a:r>
              <a:rPr lang="zh-CN" altLang="en-US" sz="1200" dirty="0"/>
              <a:t>）</a:t>
            </a:r>
          </a:p>
        </p:txBody>
      </p:sp>
      <p:sp>
        <p:nvSpPr>
          <p:cNvPr id="43" name="标题 1"/>
          <p:cNvSpPr>
            <a:spLocks noGrp="1"/>
          </p:cNvSpPr>
          <p:nvPr>
            <p:ph type="title"/>
          </p:nvPr>
        </p:nvSpPr>
        <p:spPr>
          <a:xfrm>
            <a:off x="-391090" y="217161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uPIAS2 interacts with DK212 NP</a:t>
            </a:r>
          </a:p>
        </p:txBody>
      </p:sp>
    </p:spTree>
    <p:extLst>
      <p:ext uri="{BB962C8B-B14F-4D97-AF65-F5344CB8AC3E}">
        <p14:creationId xmlns:p14="http://schemas.microsoft.com/office/powerpoint/2010/main" val="19507935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shaopo\Desktop\NP点突变修饰\2019.8.7\2019.8.8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42" y="1950468"/>
            <a:ext cx="7893497" cy="32403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29"/>
          <p:cNvSpPr txBox="1"/>
          <p:nvPr/>
        </p:nvSpPr>
        <p:spPr>
          <a:xfrm>
            <a:off x="611560" y="2043775"/>
            <a:ext cx="3888432" cy="215444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</a:t>
            </a:r>
            <a:r>
              <a:rPr lang="en-US" altLang="zh-CN" sz="800" dirty="0" err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NPwt</a:t>
            </a:r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      K7R      K48R      K87R      K90R     K91R    K103R    K113R    KO</a:t>
            </a:r>
            <a:endParaRPr lang="en-US" altLang="zh-CN" sz="8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6" name="文本框 29"/>
          <p:cNvSpPr txBox="1"/>
          <p:nvPr/>
        </p:nvSpPr>
        <p:spPr>
          <a:xfrm>
            <a:off x="4248565" y="1828331"/>
            <a:ext cx="3888432" cy="215444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</a:t>
            </a:r>
            <a:r>
              <a:rPr lang="en-US" altLang="zh-CN" sz="800" dirty="0" err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NPwt</a:t>
            </a:r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      K7R      K48R      K87R      K90R     K91R    K103R    K113R    KO</a:t>
            </a:r>
            <a:endParaRPr lang="en-US" altLang="zh-CN" sz="8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6161029" y="2799444"/>
            <a:ext cx="1820590" cy="591031"/>
            <a:chOff x="4127845" y="3860889"/>
            <a:chExt cx="1820590" cy="591031"/>
          </a:xfrm>
        </p:grpSpPr>
        <p:sp>
          <p:nvSpPr>
            <p:cNvPr id="8" name="TextBox 7"/>
            <p:cNvSpPr txBox="1"/>
            <p:nvPr/>
          </p:nvSpPr>
          <p:spPr>
            <a:xfrm>
              <a:off x="4572000" y="3860889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27845" y="4174921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</a:rPr>
                <a:t>NP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2012078" y="4365104"/>
            <a:ext cx="1820590" cy="591031"/>
            <a:chOff x="4127845" y="3860889"/>
            <a:chExt cx="1820590" cy="591031"/>
          </a:xfrm>
        </p:grpSpPr>
        <p:sp>
          <p:nvSpPr>
            <p:cNvPr id="11" name="TextBox 10"/>
            <p:cNvSpPr txBox="1"/>
            <p:nvPr/>
          </p:nvSpPr>
          <p:spPr>
            <a:xfrm>
              <a:off x="4572000" y="3860889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27845" y="4174921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</a:rPr>
                <a:t>HA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2427975" y="2873260"/>
            <a:ext cx="1820590" cy="591031"/>
            <a:chOff x="4127845" y="3860889"/>
            <a:chExt cx="1820590" cy="591031"/>
          </a:xfrm>
        </p:grpSpPr>
        <p:sp>
          <p:nvSpPr>
            <p:cNvPr id="14" name="TextBox 13"/>
            <p:cNvSpPr txBox="1"/>
            <p:nvPr/>
          </p:nvSpPr>
          <p:spPr>
            <a:xfrm>
              <a:off x="4572000" y="3860889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27845" y="4174921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</a:rPr>
                <a:t>HA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sp>
        <p:nvSpPr>
          <p:cNvPr id="16" name="文本框 29"/>
          <p:cNvSpPr txBox="1"/>
          <p:nvPr/>
        </p:nvSpPr>
        <p:spPr>
          <a:xfrm>
            <a:off x="682795" y="3678113"/>
            <a:ext cx="3804319" cy="215444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</a:t>
            </a:r>
            <a:r>
              <a:rPr lang="en-US" altLang="zh-CN" sz="800" dirty="0" err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NPwt</a:t>
            </a:r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     K184R     K198R     K227R     K229R     K273R    K325R    K470R    KO</a:t>
            </a:r>
            <a:endParaRPr lang="en-US" altLang="zh-CN" sz="8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7" name="文本框 29"/>
          <p:cNvSpPr txBox="1"/>
          <p:nvPr/>
        </p:nvSpPr>
        <p:spPr>
          <a:xfrm>
            <a:off x="4286591" y="3580908"/>
            <a:ext cx="3888432" cy="215444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</a:t>
            </a:r>
            <a:r>
              <a:rPr lang="en-US" altLang="zh-CN" sz="800" dirty="0" err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NPwt</a:t>
            </a:r>
            <a:r>
              <a: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      K7R      K48R      K87R      K90R     K91R    K103R    K113R    KO</a:t>
            </a:r>
            <a:endParaRPr lang="en-US" altLang="zh-CN" sz="8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6176101" y="3978195"/>
            <a:ext cx="1820590" cy="591031"/>
            <a:chOff x="4127845" y="3860889"/>
            <a:chExt cx="1820590" cy="591031"/>
          </a:xfrm>
        </p:grpSpPr>
        <p:sp>
          <p:nvSpPr>
            <p:cNvPr id="19" name="TextBox 18"/>
            <p:cNvSpPr txBox="1"/>
            <p:nvPr/>
          </p:nvSpPr>
          <p:spPr>
            <a:xfrm>
              <a:off x="4572000" y="3860889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127845" y="4174921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</a:rPr>
                <a:t>GAPDH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-138404" y="4291244"/>
            <a:ext cx="847618" cy="276999"/>
            <a:chOff x="822811" y="4298612"/>
            <a:chExt cx="847618" cy="276999"/>
          </a:xfrm>
        </p:grpSpPr>
        <p:cxnSp>
          <p:nvCxnSpPr>
            <p:cNvPr id="22" name="直接箭头连接符 21"/>
            <p:cNvCxnSpPr/>
            <p:nvPr/>
          </p:nvCxnSpPr>
          <p:spPr>
            <a:xfrm>
              <a:off x="1259803" y="4437112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822811" y="4298612"/>
              <a:ext cx="8476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-125221" y="2836477"/>
            <a:ext cx="847618" cy="276999"/>
            <a:chOff x="822811" y="4298612"/>
            <a:chExt cx="847618" cy="276999"/>
          </a:xfrm>
        </p:grpSpPr>
        <p:cxnSp>
          <p:nvCxnSpPr>
            <p:cNvPr id="25" name="直接箭头连接符 24"/>
            <p:cNvCxnSpPr/>
            <p:nvPr/>
          </p:nvCxnSpPr>
          <p:spPr>
            <a:xfrm>
              <a:off x="1259803" y="4437112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822811" y="4298612"/>
              <a:ext cx="8476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3972061" y="4437112"/>
            <a:ext cx="599939" cy="248410"/>
            <a:chOff x="789080" y="4305732"/>
            <a:chExt cx="847617" cy="276999"/>
          </a:xfrm>
        </p:grpSpPr>
        <p:cxnSp>
          <p:nvCxnSpPr>
            <p:cNvPr id="28" name="直接箭头连接符 27"/>
            <p:cNvCxnSpPr/>
            <p:nvPr/>
          </p:nvCxnSpPr>
          <p:spPr>
            <a:xfrm>
              <a:off x="1259803" y="4437112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789080" y="4305732"/>
              <a:ext cx="8476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3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3948595" y="4223325"/>
            <a:ext cx="599939" cy="276999"/>
            <a:chOff x="789080" y="4305732"/>
            <a:chExt cx="847617" cy="308878"/>
          </a:xfrm>
        </p:grpSpPr>
        <p:cxnSp>
          <p:nvCxnSpPr>
            <p:cNvPr id="31" name="直接箭头连接符 30"/>
            <p:cNvCxnSpPr/>
            <p:nvPr/>
          </p:nvCxnSpPr>
          <p:spPr>
            <a:xfrm>
              <a:off x="1259803" y="4437112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789080" y="4305732"/>
              <a:ext cx="847617" cy="308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2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4188085" y="3669645"/>
            <a:ext cx="599939" cy="276999"/>
            <a:chOff x="789080" y="4305732"/>
            <a:chExt cx="847617" cy="308878"/>
          </a:xfrm>
        </p:grpSpPr>
        <p:cxnSp>
          <p:nvCxnSpPr>
            <p:cNvPr id="34" name="直接箭头连接符 33"/>
            <p:cNvCxnSpPr/>
            <p:nvPr/>
          </p:nvCxnSpPr>
          <p:spPr>
            <a:xfrm>
              <a:off x="1259803" y="4437112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789080" y="4305732"/>
              <a:ext cx="847617" cy="308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1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6" name="标题 1"/>
          <p:cNvSpPr>
            <a:spLocks noGrp="1"/>
          </p:cNvSpPr>
          <p:nvPr>
            <p:ph type="title"/>
          </p:nvPr>
        </p:nvSpPr>
        <p:spPr>
          <a:xfrm>
            <a:off x="-505780" y="40466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K7, K48, and K87 of DK212 NP were potential </a:t>
            </a:r>
            <a:r>
              <a:rPr lang="en-US" altLang="zh-CN" sz="24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 site</a:t>
            </a:r>
            <a:endParaRPr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51045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6002" y="1886209"/>
            <a:ext cx="8716478" cy="3487007"/>
            <a:chOff x="-359797" y="922424"/>
            <a:chExt cx="8716478" cy="3487007"/>
          </a:xfrm>
        </p:grpSpPr>
        <p:pic>
          <p:nvPicPr>
            <p:cNvPr id="4" name="Picture 2" descr="C:\Users\shaopo\Desktop\2019.8.2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9922" y="2010297"/>
              <a:ext cx="7746759" cy="23991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 descr="C:\Users\shaopo\Desktop\图片2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57" y="922424"/>
              <a:ext cx="3960440" cy="10488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3" descr="C:\Users\shaopo\Desktop\图片2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1920" y="980728"/>
              <a:ext cx="3960440" cy="10488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" name="组合 8"/>
            <p:cNvGrpSpPr/>
            <p:nvPr/>
          </p:nvGrpSpPr>
          <p:grpSpPr>
            <a:xfrm>
              <a:off x="2603480" y="3501008"/>
              <a:ext cx="1820590" cy="668677"/>
              <a:chOff x="1167234" y="3561983"/>
              <a:chExt cx="1820590" cy="668677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 err="1">
                    <a:solidFill>
                      <a:srgbClr val="FF0000"/>
                    </a:solidFill>
                  </a:rPr>
                  <a:t>Myc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-359797" y="3454841"/>
              <a:ext cx="1063641" cy="461665"/>
              <a:chOff x="556030" y="4206279"/>
              <a:chExt cx="1063641" cy="461665"/>
            </a:xfrm>
          </p:grpSpPr>
          <p:cxnSp>
            <p:nvCxnSpPr>
              <p:cNvPr id="13" name="直接箭头连接符 12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6300192" y="2459371"/>
              <a:ext cx="1820590" cy="591031"/>
              <a:chOff x="4127845" y="3860889"/>
              <a:chExt cx="1820590" cy="591031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6300192" y="3682679"/>
              <a:ext cx="1820590" cy="591031"/>
              <a:chOff x="4127845" y="3860889"/>
              <a:chExt cx="1820590" cy="591031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GAPDH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4000261" y="2551704"/>
              <a:ext cx="847618" cy="276999"/>
              <a:chOff x="822811" y="4298612"/>
              <a:chExt cx="847618" cy="276999"/>
            </a:xfrm>
          </p:grpSpPr>
          <p:cxnSp>
            <p:nvCxnSpPr>
              <p:cNvPr id="22" name="直接箭头连接符 21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4108230" y="3429000"/>
              <a:ext cx="847618" cy="276999"/>
              <a:chOff x="822811" y="4298612"/>
              <a:chExt cx="847618" cy="276999"/>
            </a:xfrm>
          </p:grpSpPr>
          <p:cxnSp>
            <p:nvCxnSpPr>
              <p:cNvPr id="25" name="直接箭头连接符 24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3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</p:grpSp>
      <p:sp>
        <p:nvSpPr>
          <p:cNvPr id="27" name="标题 1"/>
          <p:cNvSpPr>
            <a:spLocks noGrp="1"/>
          </p:cNvSpPr>
          <p:nvPr>
            <p:ph type="title"/>
          </p:nvPr>
        </p:nvSpPr>
        <p:spPr>
          <a:xfrm>
            <a:off x="-505780" y="40466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K7, K48, and K87 of DK212 NP were potential </a:t>
            </a:r>
            <a:r>
              <a:rPr lang="en-US" altLang="zh-CN" sz="24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 site</a:t>
            </a:r>
            <a:endParaRPr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64291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187624" y="1196752"/>
            <a:ext cx="5392824" cy="5470493"/>
            <a:chOff x="1079612" y="507015"/>
            <a:chExt cx="5392824" cy="5470493"/>
          </a:xfrm>
        </p:grpSpPr>
        <p:pic>
          <p:nvPicPr>
            <p:cNvPr id="7170" name="Picture 2" descr="C:\Users\shaopo\Desktop\NP点突变第二次筛选\24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1720" y="1556792"/>
              <a:ext cx="4420716" cy="44207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" descr="C:\Users\shaopo\Desktop\图片2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9672" y="507015"/>
              <a:ext cx="4608512" cy="12204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" name="组合 14"/>
            <p:cNvGrpSpPr/>
            <p:nvPr/>
          </p:nvGrpSpPr>
          <p:grpSpPr>
            <a:xfrm>
              <a:off x="1187624" y="3429000"/>
              <a:ext cx="1063641" cy="461665"/>
              <a:chOff x="556030" y="4206279"/>
              <a:chExt cx="1063641" cy="461665"/>
            </a:xfrm>
          </p:grpSpPr>
          <p:cxnSp>
            <p:nvCxnSpPr>
              <p:cNvPr id="16" name="直接箭头连接符 15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1249469" y="4047455"/>
              <a:ext cx="1090283" cy="646331"/>
              <a:chOff x="828034" y="4206279"/>
              <a:chExt cx="847618" cy="646331"/>
            </a:xfrm>
          </p:grpSpPr>
          <p:cxnSp>
            <p:nvCxnSpPr>
              <p:cNvPr id="19" name="直接箭头连接符 18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28034" y="4206279"/>
                <a:ext cx="84761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Light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1079612" y="5013176"/>
              <a:ext cx="1063641" cy="461665"/>
              <a:chOff x="556030" y="4206279"/>
              <a:chExt cx="1063641" cy="461665"/>
            </a:xfrm>
          </p:grpSpPr>
          <p:cxnSp>
            <p:nvCxnSpPr>
              <p:cNvPr id="22" name="直接箭头连接符 21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1262856" y="2132856"/>
              <a:ext cx="847618" cy="276999"/>
              <a:chOff x="822811" y="4298612"/>
              <a:chExt cx="847618" cy="276999"/>
            </a:xfrm>
          </p:grpSpPr>
          <p:cxnSp>
            <p:nvCxnSpPr>
              <p:cNvPr id="25" name="直接箭头连接符 24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4572000" y="2271355"/>
              <a:ext cx="1820590" cy="591031"/>
              <a:chOff x="4127845" y="3860889"/>
              <a:chExt cx="1820590" cy="591031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4262078" y="5308831"/>
              <a:ext cx="1820590" cy="668677"/>
              <a:chOff x="1167234" y="3561983"/>
              <a:chExt cx="1820590" cy="668677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4612005" y="3767150"/>
              <a:ext cx="1820590" cy="668677"/>
              <a:chOff x="1167234" y="3561983"/>
              <a:chExt cx="1820590" cy="668677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</p:grpSp>
      <p:sp>
        <p:nvSpPr>
          <p:cNvPr id="36" name="标题 1"/>
          <p:cNvSpPr>
            <a:spLocks noGrp="1"/>
          </p:cNvSpPr>
          <p:nvPr>
            <p:ph type="title"/>
          </p:nvPr>
        </p:nvSpPr>
        <p:spPr>
          <a:xfrm>
            <a:off x="-505780" y="4462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K7, K48, and K87 of DK212 NP were potential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site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90700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shaopo\Desktop\PIAS NP作图\SENP及无SENP\SENP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7010" y="4126521"/>
            <a:ext cx="2289448" cy="2289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shaopo\Desktop\祖少坡实验数据\NP SUMO化\NPK7R 及SENP\2018.12.5\IP-myc（SENP）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3" y="3393131"/>
            <a:ext cx="1614487" cy="3240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组合 2"/>
          <p:cNvGrpSpPr/>
          <p:nvPr/>
        </p:nvGrpSpPr>
        <p:grpSpPr>
          <a:xfrm>
            <a:off x="1417325" y="1482841"/>
            <a:ext cx="1111945" cy="1910290"/>
            <a:chOff x="1411371" y="425175"/>
            <a:chExt cx="1111945" cy="1910290"/>
          </a:xfrm>
        </p:grpSpPr>
        <p:sp>
          <p:nvSpPr>
            <p:cNvPr id="2" name="TextBox 1"/>
            <p:cNvSpPr txBox="1"/>
            <p:nvPr/>
          </p:nvSpPr>
          <p:spPr>
            <a:xfrm rot="11377485">
              <a:off x="1411371" y="473707"/>
              <a:ext cx="553998" cy="18617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ENP1+SUMO1+UBC9+PIAS2</a:t>
              </a:r>
              <a:endParaRPr lang="zh-CN" altLang="en-US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1377485">
              <a:off x="1969318" y="425175"/>
              <a:ext cx="553998" cy="18617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PCAGGS+SUMO1+UBC9+PIAS2</a:t>
              </a:r>
              <a:endParaRPr lang="zh-CN" altLang="en-US" sz="1200" dirty="0"/>
            </a:p>
          </p:txBody>
        </p:sp>
      </p:grpSp>
      <p:cxnSp>
        <p:nvCxnSpPr>
          <p:cNvPr id="11" name="直接箭头连接符 10"/>
          <p:cNvCxnSpPr/>
          <p:nvPr/>
        </p:nvCxnSpPr>
        <p:spPr>
          <a:xfrm>
            <a:off x="683912" y="5013176"/>
            <a:ext cx="57572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-63163" y="4782343"/>
            <a:ext cx="8476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High-chain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55KD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grpSp>
        <p:nvGrpSpPr>
          <p:cNvPr id="14" name="组合 13"/>
          <p:cNvGrpSpPr/>
          <p:nvPr/>
        </p:nvGrpSpPr>
        <p:grpSpPr>
          <a:xfrm>
            <a:off x="5919098" y="2110297"/>
            <a:ext cx="1111945" cy="1910290"/>
            <a:chOff x="1411371" y="425175"/>
            <a:chExt cx="1111945" cy="1910290"/>
          </a:xfrm>
        </p:grpSpPr>
        <p:sp>
          <p:nvSpPr>
            <p:cNvPr id="15" name="TextBox 14"/>
            <p:cNvSpPr txBox="1"/>
            <p:nvPr/>
          </p:nvSpPr>
          <p:spPr>
            <a:xfrm rot="11377485">
              <a:off x="1411371" y="473707"/>
              <a:ext cx="553998" cy="18617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ENP1+SUMO1+UBC9+PIAS2</a:t>
              </a:r>
              <a:endParaRPr lang="zh-CN" alt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1377485">
              <a:off x="1969318" y="425175"/>
              <a:ext cx="553998" cy="18617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PCAGGS+SUMO1+UBC9+PIAS2</a:t>
              </a:r>
              <a:endParaRPr lang="zh-CN" altLang="en-US" sz="1200" dirty="0"/>
            </a:p>
          </p:txBody>
        </p:sp>
      </p:grpSp>
      <p:cxnSp>
        <p:nvCxnSpPr>
          <p:cNvPr id="17" name="直接箭头连接符 16"/>
          <p:cNvCxnSpPr/>
          <p:nvPr/>
        </p:nvCxnSpPr>
        <p:spPr>
          <a:xfrm>
            <a:off x="5055002" y="5422665"/>
            <a:ext cx="35986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567424" y="5289682"/>
            <a:ext cx="5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55KD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478938" y="4787239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100KD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4998030" y="4923153"/>
            <a:ext cx="35986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767359" y="5979799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V5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087174" y="5566681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npu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600734" y="5132745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87624" y="5560230"/>
            <a:ext cx="1863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solidFill>
                  <a:srgbClr val="FF0000"/>
                </a:solidFill>
              </a:rPr>
              <a:t>Myc</a:t>
            </a:r>
            <a:r>
              <a:rPr lang="en-US" altLang="zh-CN" sz="1200" dirty="0">
                <a:solidFill>
                  <a:srgbClr val="FF0000"/>
                </a:solidFill>
              </a:rPr>
              <a:t>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26" name="标题 1"/>
          <p:cNvSpPr>
            <a:spLocks noGrp="1"/>
          </p:cNvSpPr>
          <p:nvPr>
            <p:ph type="title"/>
          </p:nvPr>
        </p:nvSpPr>
        <p:spPr>
          <a:xfrm>
            <a:off x="-540568" y="187539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duSENP1 inhibited the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of DK212 NP promoted by duPIAS2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43922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07504" y="892628"/>
            <a:ext cx="8935140" cy="5632716"/>
            <a:chOff x="107504" y="388572"/>
            <a:chExt cx="8935140" cy="5632716"/>
          </a:xfrm>
        </p:grpSpPr>
        <p:pic>
          <p:nvPicPr>
            <p:cNvPr id="4" name="Picture 7" descr="C:\Users\shaopo\Desktop\祖少坡实验数据\NP SUMO化\NPK7R 及SENP\2018.12.5.2\最左边myc抗体，GAPDH右边IP-NP最右边NP下面IP-HA及HA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7504" y="2060848"/>
              <a:ext cx="8935140" cy="39604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" name="组合 4"/>
            <p:cNvGrpSpPr/>
            <p:nvPr/>
          </p:nvGrpSpPr>
          <p:grpSpPr>
            <a:xfrm>
              <a:off x="3924459" y="482087"/>
              <a:ext cx="859294" cy="2386030"/>
              <a:chOff x="1494703" y="24960"/>
              <a:chExt cx="987146" cy="2073403"/>
            </a:xfrm>
          </p:grpSpPr>
          <p:sp>
            <p:nvSpPr>
              <p:cNvPr id="6" name="TextBox 5"/>
              <p:cNvSpPr txBox="1"/>
              <p:nvPr/>
            </p:nvSpPr>
            <p:spPr>
              <a:xfrm rot="11377485">
                <a:off x="1494703" y="69118"/>
                <a:ext cx="424284" cy="202893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SENP1+SUMO1+UBC9+PIAS2</a:t>
                </a:r>
                <a:endParaRPr lang="zh-CN" altLang="en-US" sz="12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1377485">
                <a:off x="2057565" y="24960"/>
                <a:ext cx="424284" cy="207340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PCAGGS+SUMO1+UBC9+PIAS2</a:t>
                </a:r>
                <a:endParaRPr lang="zh-CN" altLang="en-US" sz="1200" dirty="0"/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6085475" y="461161"/>
              <a:ext cx="854217" cy="2406661"/>
              <a:chOff x="1495594" y="69350"/>
              <a:chExt cx="981314" cy="2091331"/>
            </a:xfrm>
          </p:grpSpPr>
          <p:sp>
            <p:nvSpPr>
              <p:cNvPr id="9" name="TextBox 8"/>
              <p:cNvSpPr txBox="1"/>
              <p:nvPr/>
            </p:nvSpPr>
            <p:spPr>
              <a:xfrm rot="11377485">
                <a:off x="1495594" y="123681"/>
                <a:ext cx="424284" cy="20370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SENP1+SUMO1+UBC9+PIAS2</a:t>
                </a:r>
                <a:endParaRPr lang="zh-CN" altLang="en-US" sz="12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1377485">
                <a:off x="2052624" y="69350"/>
                <a:ext cx="424284" cy="20286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PCAGGS+SUMO1+UBC9+PIAS2</a:t>
                </a:r>
                <a:endParaRPr lang="zh-CN" altLang="en-US" sz="1200" dirty="0"/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8029690" y="388572"/>
              <a:ext cx="854266" cy="2407242"/>
              <a:chOff x="1495594" y="68845"/>
              <a:chExt cx="981371" cy="2091836"/>
            </a:xfrm>
          </p:grpSpPr>
          <p:sp>
            <p:nvSpPr>
              <p:cNvPr id="12" name="TextBox 11"/>
              <p:cNvSpPr txBox="1"/>
              <p:nvPr/>
            </p:nvSpPr>
            <p:spPr>
              <a:xfrm rot="11377485">
                <a:off x="1495594" y="123681"/>
                <a:ext cx="424284" cy="20370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SENP1+SUMO1+UBC9+PIAS2</a:t>
                </a:r>
                <a:endParaRPr lang="zh-CN" altLang="en-US" sz="12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1377485">
                <a:off x="2052681" y="68845"/>
                <a:ext cx="424284" cy="202920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PCAGGS+SUMO1+UBC9+PIAS2</a:t>
                </a:r>
                <a:endParaRPr lang="zh-CN" altLang="en-US" sz="1200" dirty="0"/>
              </a:p>
            </p:txBody>
          </p:sp>
        </p:grpSp>
        <p:cxnSp>
          <p:nvCxnSpPr>
            <p:cNvPr id="14" name="直接箭头连接符 13"/>
            <p:cNvCxnSpPr/>
            <p:nvPr/>
          </p:nvCxnSpPr>
          <p:spPr>
            <a:xfrm>
              <a:off x="2339924" y="3501008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907704" y="3362508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3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744234" y="4437112"/>
              <a:ext cx="1863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GAPDH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419872" y="4036715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cxnSp>
          <p:nvCxnSpPr>
            <p:cNvPr id="18" name="直接箭头连接符 17"/>
            <p:cNvCxnSpPr/>
            <p:nvPr/>
          </p:nvCxnSpPr>
          <p:spPr>
            <a:xfrm>
              <a:off x="4716016" y="3068960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4014177" y="2838127"/>
              <a:ext cx="8476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High-chain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55KD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087281" y="3270175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087281" y="4797152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021101" y="4797152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P-Flag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828172" y="3316728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P-Flag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080668" y="3131675"/>
              <a:ext cx="1728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NP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021793" y="4520153"/>
              <a:ext cx="15719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HA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Rabbit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cxnSp>
          <p:nvCxnSpPr>
            <p:cNvPr id="26" name="直接箭头连接符 25"/>
            <p:cNvCxnSpPr/>
            <p:nvPr/>
          </p:nvCxnSpPr>
          <p:spPr>
            <a:xfrm>
              <a:off x="4648238" y="4365104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4300446" y="4226604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28" name="标题 1"/>
          <p:cNvSpPr>
            <a:spLocks noGrp="1"/>
          </p:cNvSpPr>
          <p:nvPr>
            <p:ph type="title"/>
          </p:nvPr>
        </p:nvSpPr>
        <p:spPr>
          <a:xfrm>
            <a:off x="-609562" y="-975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duSENP1 inhibited the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of DK212 NP promoted by duPIAS2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5409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0" y="3573016"/>
            <a:ext cx="3661626" cy="3024336"/>
            <a:chOff x="228022" y="764704"/>
            <a:chExt cx="3794720" cy="3075003"/>
          </a:xfrm>
        </p:grpSpPr>
        <p:pic>
          <p:nvPicPr>
            <p:cNvPr id="2050" name="Picture 2" descr="C:\Users\shaopo\Desktop\祖少坡实验数据\NP SUMO化\第二次6个DishPIAS及PIASmu\2018.11.11\二次PIAS2上清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552" y="764704"/>
              <a:ext cx="3483190" cy="30750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2191913" y="3356992"/>
              <a:ext cx="15719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HA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Rabbit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236383" y="3310825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8022" y="1484784"/>
              <a:ext cx="6715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  <p:cxnSp>
          <p:nvCxnSpPr>
            <p:cNvPr id="8" name="直接箭头连接符 7"/>
            <p:cNvCxnSpPr/>
            <p:nvPr/>
          </p:nvCxnSpPr>
          <p:spPr>
            <a:xfrm>
              <a:off x="683568" y="1628800"/>
              <a:ext cx="43204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/>
          <p:cNvGrpSpPr/>
          <p:nvPr/>
        </p:nvGrpSpPr>
        <p:grpSpPr>
          <a:xfrm>
            <a:off x="1161804" y="1880362"/>
            <a:ext cx="2374306" cy="1906128"/>
            <a:chOff x="1161804" y="58965"/>
            <a:chExt cx="2374306" cy="1906128"/>
          </a:xfrm>
        </p:grpSpPr>
        <p:sp>
          <p:nvSpPr>
            <p:cNvPr id="10" name="TextBox 9"/>
            <p:cNvSpPr txBox="1"/>
            <p:nvPr/>
          </p:nvSpPr>
          <p:spPr>
            <a:xfrm rot="11485623">
              <a:off x="1161804" y="316049"/>
              <a:ext cx="369332" cy="16467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+E2+SUMO1+NP</a:t>
              </a:r>
              <a:endParaRPr lang="zh-CN" alt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1485623">
              <a:off x="1528744" y="88083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mu+E2+SUMO1+NP</a:t>
              </a:r>
              <a:endParaRPr lang="zh-CN" alt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1485623">
              <a:off x="1944889" y="88084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E2+SUMO1+NP</a:t>
              </a:r>
              <a:endParaRPr lang="zh-CN" altLang="en-US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1485623">
              <a:off x="2353553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SUMO1+NP</a:t>
              </a:r>
              <a:endParaRPr lang="zh-CN" alt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1485623">
              <a:off x="2771298" y="8808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NP</a:t>
              </a:r>
              <a:endParaRPr lang="zh-CN" alt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1485623">
              <a:off x="3166778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</a:t>
              </a:r>
              <a:endParaRPr lang="zh-CN" altLang="en-US" sz="1200" dirty="0"/>
            </a:p>
          </p:txBody>
        </p:sp>
      </p:grpSp>
      <p:pic>
        <p:nvPicPr>
          <p:cNvPr id="2051" name="Picture 3" descr="C:\Users\shaopo\Desktop\祖少坡实验数据\NP SUMO化\第二次6个DishPIAS及PIASmu\2018.11.12.2\2018.11.12.3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4268" y="3804473"/>
            <a:ext cx="5722428" cy="26333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3923928" y="5912244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683570" y="5958410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HA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Rabbit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452320" y="6004577"/>
            <a:ext cx="1571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NP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grpSp>
        <p:nvGrpSpPr>
          <p:cNvPr id="23" name="组合 22"/>
          <p:cNvGrpSpPr/>
          <p:nvPr/>
        </p:nvGrpSpPr>
        <p:grpSpPr>
          <a:xfrm>
            <a:off x="4213918" y="2160162"/>
            <a:ext cx="2374306" cy="1906128"/>
            <a:chOff x="1161804" y="58965"/>
            <a:chExt cx="2374306" cy="1906128"/>
          </a:xfrm>
        </p:grpSpPr>
        <p:sp>
          <p:nvSpPr>
            <p:cNvPr id="24" name="TextBox 23"/>
            <p:cNvSpPr txBox="1"/>
            <p:nvPr/>
          </p:nvSpPr>
          <p:spPr>
            <a:xfrm rot="11485623">
              <a:off x="1161804" y="316049"/>
              <a:ext cx="369332" cy="16467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+E2+SUMO1+NP</a:t>
              </a:r>
              <a:endParaRPr lang="zh-CN" altLang="en-US" sz="12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1485623">
              <a:off x="1528744" y="88083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mu+E2+SUMO1+NP</a:t>
              </a:r>
              <a:endParaRPr lang="zh-CN" altLang="en-US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1485623">
              <a:off x="1944889" y="88084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E2+SUMO1+NP</a:t>
              </a:r>
              <a:endParaRPr lang="zh-CN" altLang="en-US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1485623">
              <a:off x="2353553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SUMO1+NP</a:t>
              </a:r>
              <a:endParaRPr lang="zh-CN" altLang="en-US" sz="12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1485623">
              <a:off x="2771298" y="8808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NP</a:t>
              </a:r>
              <a:endParaRPr lang="zh-CN" altLang="en-US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1485623">
              <a:off x="3166778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</a:t>
              </a:r>
              <a:endParaRPr lang="zh-CN" altLang="en-US" sz="1200" dirty="0"/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6948264" y="2171299"/>
            <a:ext cx="2374306" cy="1906128"/>
            <a:chOff x="1161804" y="58965"/>
            <a:chExt cx="2374306" cy="1906128"/>
          </a:xfrm>
        </p:grpSpPr>
        <p:sp>
          <p:nvSpPr>
            <p:cNvPr id="31" name="TextBox 30"/>
            <p:cNvSpPr txBox="1"/>
            <p:nvPr/>
          </p:nvSpPr>
          <p:spPr>
            <a:xfrm rot="11485623">
              <a:off x="1161804" y="316049"/>
              <a:ext cx="369332" cy="16467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+E2+SUMO1+NP</a:t>
              </a:r>
              <a:endParaRPr lang="zh-CN" altLang="en-US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1485623">
              <a:off x="1528744" y="88083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IAS2mu+E2+SUMO1+NP</a:t>
              </a:r>
              <a:endParaRPr lang="zh-CN" altLang="en-US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1485623">
              <a:off x="1944889" y="88084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E2+SUMO1+NP</a:t>
              </a:r>
              <a:endParaRPr lang="zh-CN" altLang="en-US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1485623">
              <a:off x="2353553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SUMO1+NP</a:t>
              </a:r>
              <a:endParaRPr lang="zh-CN" altLang="en-US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 rot="11485623">
              <a:off x="2771298" y="8808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+NP</a:t>
              </a:r>
              <a:endParaRPr lang="zh-CN" altLang="en-US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 rot="11485623">
              <a:off x="3166778" y="58965"/>
              <a:ext cx="369332" cy="18770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PCAGGS</a:t>
              </a:r>
              <a:endParaRPr lang="zh-CN" altLang="en-US" sz="1200" dirty="0"/>
            </a:p>
          </p:txBody>
        </p:sp>
      </p:grpSp>
      <p:cxnSp>
        <p:nvCxnSpPr>
          <p:cNvPr id="37" name="直接箭头连接符 36"/>
          <p:cNvCxnSpPr/>
          <p:nvPr/>
        </p:nvCxnSpPr>
        <p:spPr>
          <a:xfrm>
            <a:off x="6336667" y="4890357"/>
            <a:ext cx="57572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524582" y="4668124"/>
            <a:ext cx="8476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</a:rPr>
              <a:t>High-chain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55KD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446246" y="5915087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0" name="标题 1"/>
          <p:cNvSpPr>
            <a:spLocks noGrp="1"/>
          </p:cNvSpPr>
          <p:nvPr>
            <p:ph type="title"/>
          </p:nvPr>
        </p:nvSpPr>
        <p:spPr>
          <a:xfrm>
            <a:off x="-574230" y="521119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sz="2000" dirty="0">
                <a:latin typeface="Times New Roman" panose="02020603050405020304" charset="0"/>
                <a:cs typeface="Times New Roman" panose="02020603050405020304" charset="0"/>
              </a:rPr>
              <a:t>uPIAS2 promotes </a:t>
            </a:r>
            <a:r>
              <a:rPr lang="en-US" sz="2000" dirty="0">
                <a:latin typeface="Times New Roman" panose="02020603050405020304" charset="0"/>
                <a:cs typeface="Times New Roman" panose="02020603050405020304" charset="0"/>
              </a:rPr>
              <a:t>DK212 </a:t>
            </a:r>
            <a:r>
              <a:rPr sz="2000" dirty="0">
                <a:latin typeface="Times New Roman" panose="02020603050405020304" charset="0"/>
                <a:cs typeface="Times New Roman" panose="02020603050405020304" charset="0"/>
              </a:rPr>
              <a:t>NP </a:t>
            </a:r>
            <a:r>
              <a:rPr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sz="2000" dirty="0">
                <a:latin typeface="Times New Roman" panose="02020603050405020304" charset="0"/>
                <a:cs typeface="Times New Roman" panose="02020603050405020304" charset="0"/>
              </a:rPr>
              <a:t> by SUMO1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40251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56030" y="1525278"/>
            <a:ext cx="2858689" cy="4856050"/>
            <a:chOff x="556030" y="313640"/>
            <a:chExt cx="2858689" cy="4856050"/>
          </a:xfrm>
        </p:grpSpPr>
        <p:pic>
          <p:nvPicPr>
            <p:cNvPr id="2053" name="Picture 5" descr="C:\Users\shaopo\Desktop\祖少坡实验数据\NP SUMO化\SUMO及SUMOmu\2018.12.1.2\2018.12.1.2IP-SUMO，IP-SUMOmu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9671" y="2332230"/>
              <a:ext cx="1767547" cy="28374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组合 5"/>
            <p:cNvGrpSpPr/>
            <p:nvPr/>
          </p:nvGrpSpPr>
          <p:grpSpPr>
            <a:xfrm>
              <a:off x="2375348" y="313640"/>
              <a:ext cx="1039371" cy="1956740"/>
              <a:chOff x="2375348" y="313640"/>
              <a:chExt cx="1039371" cy="1956740"/>
            </a:xfrm>
          </p:grpSpPr>
          <p:sp>
            <p:nvSpPr>
              <p:cNvPr id="5" name="TextBox 4"/>
              <p:cNvSpPr txBox="1"/>
              <p:nvPr/>
            </p:nvSpPr>
            <p:spPr>
              <a:xfrm rot="11877074">
                <a:off x="2375348" y="407817"/>
                <a:ext cx="369332" cy="181419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SUMO1+UBC9+PIAS2</a:t>
                </a:r>
                <a:endParaRPr lang="zh-CN" altLang="en-US" sz="12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1877074">
                <a:off x="3045387" y="313640"/>
                <a:ext cx="369332" cy="195674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SUMO1mu+UBC9+PIAS2</a:t>
                </a:r>
                <a:endParaRPr lang="zh-CN" altLang="en-US" sz="1200" dirty="0"/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556030" y="4206279"/>
              <a:ext cx="1063641" cy="461665"/>
              <a:chOff x="556030" y="4206279"/>
              <a:chExt cx="1063641" cy="461665"/>
            </a:xfrm>
          </p:grpSpPr>
          <p:cxnSp>
            <p:nvCxnSpPr>
              <p:cNvPr id="20" name="直接箭头连接符 19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2195736" y="4499828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P-Flag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547664" y="4855718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>
                  <a:solidFill>
                    <a:srgbClr val="FF0000"/>
                  </a:solidFill>
                </a:rPr>
                <a:t>Myc</a:t>
              </a:r>
              <a:r>
                <a:rPr lang="en-US" altLang="zh-CN" sz="1200" dirty="0">
                  <a:solidFill>
                    <a:srgbClr val="FF0000"/>
                  </a:solidFill>
                </a:rPr>
                <a:t>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sp>
        <p:nvSpPr>
          <p:cNvPr id="12" name="标题 1"/>
          <p:cNvSpPr>
            <a:spLocks noGrp="1"/>
          </p:cNvSpPr>
          <p:nvPr>
            <p:ph type="title"/>
          </p:nvPr>
        </p:nvSpPr>
        <p:spPr>
          <a:xfrm>
            <a:off x="-361850" y="-3123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duPIAS2 promotes DK212 NP </a:t>
            </a:r>
            <a:r>
              <a:rPr lang="en-US" altLang="zh-CN" sz="24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 by duSUMO1</a:t>
            </a:r>
            <a:endParaRPr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62886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 descr="C:\Users\shaopo\Desktop\祖少坡实验数据\NP SUMO化\SUMO及SUMOmu\2018.11.27.3\PIAS，IP-PIAS，下面GAPDH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728" y="2656738"/>
            <a:ext cx="3203401" cy="28516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C:\Users\shaopo\Desktop\祖少坡实验数据\NP SUMO化\SUMO及SUMOmu\2018.12.1.2\NP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2515702"/>
            <a:ext cx="2419374" cy="32175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shaopo\Desktop\祖少坡实验数据\NP SUMO化\SUMO及SUMOmu\2018.11.27.3\NP上清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9486" y="2497337"/>
            <a:ext cx="1512168" cy="30110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组合 6"/>
          <p:cNvGrpSpPr/>
          <p:nvPr/>
        </p:nvGrpSpPr>
        <p:grpSpPr>
          <a:xfrm>
            <a:off x="1209690" y="1099919"/>
            <a:ext cx="1202070" cy="1485063"/>
            <a:chOff x="2225376" y="772743"/>
            <a:chExt cx="1202070" cy="1485063"/>
          </a:xfrm>
        </p:grpSpPr>
        <p:sp>
          <p:nvSpPr>
            <p:cNvPr id="8" name="TextBox 7"/>
            <p:cNvSpPr txBox="1"/>
            <p:nvPr/>
          </p:nvSpPr>
          <p:spPr>
            <a:xfrm rot="11877074">
              <a:off x="2225376" y="772743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1+UBC9+PIAS2</a:t>
              </a:r>
              <a:endParaRPr lang="zh-CN" alt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1877074">
              <a:off x="2873448" y="817646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mu+UBC9+PIAS2</a:t>
              </a:r>
              <a:endParaRPr lang="zh-CN" altLang="en-US" sz="1200" dirty="0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2577842" y="1218115"/>
            <a:ext cx="1202070" cy="1485063"/>
            <a:chOff x="2225376" y="772743"/>
            <a:chExt cx="1202070" cy="1485063"/>
          </a:xfrm>
        </p:grpSpPr>
        <p:sp>
          <p:nvSpPr>
            <p:cNvPr id="11" name="TextBox 10"/>
            <p:cNvSpPr txBox="1"/>
            <p:nvPr/>
          </p:nvSpPr>
          <p:spPr>
            <a:xfrm rot="11877074">
              <a:off x="2225376" y="772743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1+UBC9+PIAS2</a:t>
              </a:r>
              <a:endParaRPr lang="zh-CN" alt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1877074">
              <a:off x="2873448" y="817646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mu+UBC9+PIAS2</a:t>
              </a:r>
              <a:endParaRPr lang="zh-CN" altLang="en-US" sz="1200" dirty="0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4204535" y="1046280"/>
            <a:ext cx="1202070" cy="1485063"/>
            <a:chOff x="2225376" y="772743"/>
            <a:chExt cx="1202070" cy="1485063"/>
          </a:xfrm>
        </p:grpSpPr>
        <p:sp>
          <p:nvSpPr>
            <p:cNvPr id="14" name="TextBox 13"/>
            <p:cNvSpPr txBox="1"/>
            <p:nvPr/>
          </p:nvSpPr>
          <p:spPr>
            <a:xfrm rot="11877074">
              <a:off x="2225376" y="772743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1+UBC9+PIAS2</a:t>
              </a:r>
              <a:endParaRPr lang="zh-CN" alt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1877074">
              <a:off x="2873448" y="817646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mu+UBC9+PIAS2</a:t>
              </a:r>
              <a:endParaRPr lang="zh-CN" altLang="en-US" sz="1200" dirty="0"/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7020272" y="1223532"/>
            <a:ext cx="1202070" cy="1485063"/>
            <a:chOff x="2225376" y="772743"/>
            <a:chExt cx="1202070" cy="1485063"/>
          </a:xfrm>
        </p:grpSpPr>
        <p:sp>
          <p:nvSpPr>
            <p:cNvPr id="17" name="TextBox 16"/>
            <p:cNvSpPr txBox="1"/>
            <p:nvPr/>
          </p:nvSpPr>
          <p:spPr>
            <a:xfrm rot="11877074">
              <a:off x="2225376" y="772743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1+UBC9+PIAS2</a:t>
              </a:r>
              <a:endParaRPr lang="zh-CN" alt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1877074">
              <a:off x="2873448" y="817646"/>
              <a:ext cx="553998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/>
                <a:t>NP+SUMOmu+UBC9+PIAS2</a:t>
              </a:r>
              <a:endParaRPr lang="zh-CN" altLang="en-US" sz="1200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2779514" y="5041944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87791" y="4882974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P-Flag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566878" y="692695"/>
            <a:ext cx="1357554" cy="5034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196079" y="698345"/>
            <a:ext cx="1357554" cy="5034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1408715" y="5077352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npu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403648" y="4855716"/>
            <a:ext cx="182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GAPDH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99282" y="2933150"/>
            <a:ext cx="182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HA 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Rabbit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grpSp>
        <p:nvGrpSpPr>
          <p:cNvPr id="28" name="组合 27"/>
          <p:cNvGrpSpPr/>
          <p:nvPr/>
        </p:nvGrpSpPr>
        <p:grpSpPr>
          <a:xfrm>
            <a:off x="159900" y="4717216"/>
            <a:ext cx="739520" cy="276999"/>
            <a:chOff x="159900" y="4717216"/>
            <a:chExt cx="739520" cy="276999"/>
          </a:xfrm>
        </p:grpSpPr>
        <p:cxnSp>
          <p:nvCxnSpPr>
            <p:cNvPr id="26" name="直接箭头连接符 25"/>
            <p:cNvCxnSpPr/>
            <p:nvPr/>
          </p:nvCxnSpPr>
          <p:spPr>
            <a:xfrm>
              <a:off x="539552" y="4855716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159900" y="4717216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3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160072" y="3985979"/>
            <a:ext cx="739520" cy="276999"/>
            <a:chOff x="159900" y="4717216"/>
            <a:chExt cx="739520" cy="276999"/>
          </a:xfrm>
        </p:grpSpPr>
        <p:cxnSp>
          <p:nvCxnSpPr>
            <p:cNvPr id="30" name="直接箭头连接符 29"/>
            <p:cNvCxnSpPr/>
            <p:nvPr/>
          </p:nvCxnSpPr>
          <p:spPr>
            <a:xfrm>
              <a:off x="539552" y="4855716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159900" y="4717216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3563888" y="3584049"/>
            <a:ext cx="739520" cy="276999"/>
            <a:chOff x="159900" y="4717216"/>
            <a:chExt cx="739520" cy="276999"/>
          </a:xfrm>
        </p:grpSpPr>
        <p:cxnSp>
          <p:nvCxnSpPr>
            <p:cNvPr id="33" name="直接箭头连接符 32"/>
            <p:cNvCxnSpPr/>
            <p:nvPr/>
          </p:nvCxnSpPr>
          <p:spPr>
            <a:xfrm>
              <a:off x="539552" y="4855716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159900" y="4717216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3983439" y="4440217"/>
            <a:ext cx="182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NP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grpSp>
        <p:nvGrpSpPr>
          <p:cNvPr id="36" name="组合 35"/>
          <p:cNvGrpSpPr/>
          <p:nvPr/>
        </p:nvGrpSpPr>
        <p:grpSpPr>
          <a:xfrm>
            <a:off x="5642400" y="3736449"/>
            <a:ext cx="739520" cy="276999"/>
            <a:chOff x="159900" y="4717216"/>
            <a:chExt cx="739520" cy="276999"/>
          </a:xfrm>
        </p:grpSpPr>
        <p:cxnSp>
          <p:nvCxnSpPr>
            <p:cNvPr id="37" name="直接箭头连接符 36"/>
            <p:cNvCxnSpPr/>
            <p:nvPr/>
          </p:nvCxnSpPr>
          <p:spPr>
            <a:xfrm>
              <a:off x="539552" y="4855716"/>
              <a:ext cx="35986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159900" y="4717216"/>
              <a:ext cx="559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55KD 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7092280" y="4994215"/>
            <a:ext cx="93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Inpu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49599" y="4578717"/>
            <a:ext cx="182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</a:rPr>
              <a:t>NP antibody</a:t>
            </a:r>
            <a:r>
              <a:rPr lang="zh-CN" altLang="en-US" sz="1200" dirty="0">
                <a:solidFill>
                  <a:srgbClr val="FF0000"/>
                </a:solidFill>
              </a:rPr>
              <a:t>（</a:t>
            </a:r>
            <a:r>
              <a:rPr lang="en-US" altLang="zh-CN" sz="1200" dirty="0">
                <a:solidFill>
                  <a:srgbClr val="FF0000"/>
                </a:solidFill>
              </a:rPr>
              <a:t>Mouse</a:t>
            </a:r>
            <a:r>
              <a:rPr lang="zh-CN" altLang="en-US" sz="1200" dirty="0">
                <a:solidFill>
                  <a:srgbClr val="FF0000"/>
                </a:solidFill>
              </a:rPr>
              <a:t>）</a:t>
            </a:r>
          </a:p>
        </p:txBody>
      </p:sp>
      <p:sp>
        <p:nvSpPr>
          <p:cNvPr id="41" name="标题 1"/>
          <p:cNvSpPr>
            <a:spLocks noGrp="1"/>
          </p:cNvSpPr>
          <p:nvPr>
            <p:ph type="title"/>
          </p:nvPr>
        </p:nvSpPr>
        <p:spPr>
          <a:xfrm>
            <a:off x="-180528" y="-92560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duPIAS2 promotes DK212 NP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by duSUMO1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9559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0" y="1564655"/>
            <a:ext cx="8950326" cy="4528641"/>
            <a:chOff x="-180528" y="628551"/>
            <a:chExt cx="9130854" cy="4528641"/>
          </a:xfrm>
        </p:grpSpPr>
        <p:pic>
          <p:nvPicPr>
            <p:cNvPr id="3074" name="Picture 2" descr="C:\Users\shaopo\Desktop\PIAS NP作图\SUMO2、mu修饰NP\原图\珠子myc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568" y="1916832"/>
              <a:ext cx="2374615" cy="3240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" name="组合 4"/>
            <p:cNvGrpSpPr/>
            <p:nvPr/>
          </p:nvGrpSpPr>
          <p:grpSpPr>
            <a:xfrm>
              <a:off x="1522663" y="628551"/>
              <a:ext cx="1634118" cy="1370496"/>
              <a:chOff x="1522663" y="628551"/>
              <a:chExt cx="1634118" cy="1370496"/>
            </a:xfrm>
          </p:grpSpPr>
          <p:sp>
            <p:nvSpPr>
              <p:cNvPr id="4" name="TextBox 3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1691680" y="4509120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P-Flag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214095" y="4739952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>
                  <a:solidFill>
                    <a:srgbClr val="FF0000"/>
                  </a:solidFill>
                </a:rPr>
                <a:t>Myc</a:t>
              </a:r>
              <a:r>
                <a:rPr lang="en-US" altLang="zh-CN" sz="1200" dirty="0">
                  <a:solidFill>
                    <a:srgbClr val="FF0000"/>
                  </a:solidFill>
                </a:rPr>
                <a:t>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  <p:grpSp>
          <p:nvGrpSpPr>
            <p:cNvPr id="16" name="组合 15"/>
            <p:cNvGrpSpPr/>
            <p:nvPr/>
          </p:nvGrpSpPr>
          <p:grpSpPr>
            <a:xfrm>
              <a:off x="-180528" y="4221088"/>
              <a:ext cx="1063641" cy="461665"/>
              <a:chOff x="556030" y="4206279"/>
              <a:chExt cx="1063641" cy="461665"/>
            </a:xfrm>
          </p:grpSpPr>
          <p:cxnSp>
            <p:nvCxnSpPr>
              <p:cNvPr id="17" name="直接箭头连接符 16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pic>
          <p:nvPicPr>
            <p:cNvPr id="3078" name="Picture 6" descr="C:\Users\shaopo\Desktop\PIAS NP作图\SUMO2、mu修饰NP\原图\上清NP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14520" y="2392462"/>
              <a:ext cx="2289100" cy="2289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组合 5"/>
            <p:cNvGrpSpPr/>
            <p:nvPr/>
          </p:nvGrpSpPr>
          <p:grpSpPr>
            <a:xfrm>
              <a:off x="4127845" y="3860889"/>
              <a:ext cx="1820590" cy="591031"/>
              <a:chOff x="4127845" y="3860889"/>
              <a:chExt cx="1820590" cy="591031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3280227" y="3398512"/>
              <a:ext cx="847618" cy="276999"/>
              <a:chOff x="822811" y="4298612"/>
              <a:chExt cx="847618" cy="276999"/>
            </a:xfrm>
          </p:grpSpPr>
          <p:cxnSp>
            <p:nvCxnSpPr>
              <p:cNvPr id="23" name="直接箭头连接符 22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4285875" y="1021966"/>
              <a:ext cx="1634118" cy="1370496"/>
              <a:chOff x="1522663" y="628551"/>
              <a:chExt cx="1634118" cy="1370496"/>
            </a:xfrm>
          </p:grpSpPr>
          <p:sp>
            <p:nvSpPr>
              <p:cNvPr id="27" name="TextBox 26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pic>
          <p:nvPicPr>
            <p:cNvPr id="3079" name="Picture 7" descr="C:\Users\shaopo\Desktop\PIAS NP作图\SUMO2、mu修饰NP\原图\GAPDH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03860" y="2617758"/>
              <a:ext cx="2246466" cy="18385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1" name="组合 30"/>
            <p:cNvGrpSpPr/>
            <p:nvPr/>
          </p:nvGrpSpPr>
          <p:grpSpPr>
            <a:xfrm>
              <a:off x="5956630" y="3204213"/>
              <a:ext cx="847618" cy="276999"/>
              <a:chOff x="850009" y="4298612"/>
              <a:chExt cx="847618" cy="276999"/>
            </a:xfrm>
          </p:grpSpPr>
          <p:cxnSp>
            <p:nvCxnSpPr>
              <p:cNvPr id="32" name="直接箭头连接符 31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850009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3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34" name="组合 33"/>
            <p:cNvGrpSpPr/>
            <p:nvPr/>
          </p:nvGrpSpPr>
          <p:grpSpPr>
            <a:xfrm>
              <a:off x="7287681" y="1231584"/>
              <a:ext cx="1634118" cy="1370496"/>
              <a:chOff x="1522663" y="628551"/>
              <a:chExt cx="1634118" cy="1370496"/>
            </a:xfrm>
          </p:grpSpPr>
          <p:sp>
            <p:nvSpPr>
              <p:cNvPr id="35" name="TextBox 34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sp>
          <p:nvSpPr>
            <p:cNvPr id="38" name="TextBox 37"/>
            <p:cNvSpPr txBox="1"/>
            <p:nvPr/>
          </p:nvSpPr>
          <p:spPr>
            <a:xfrm>
              <a:off x="7552942" y="3700316"/>
              <a:ext cx="932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Input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916798" y="4072010"/>
              <a:ext cx="182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</a:rPr>
                <a:t>GAPDH antibody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（</a:t>
              </a:r>
              <a:r>
                <a:rPr lang="en-US" altLang="zh-CN" sz="1200" dirty="0">
                  <a:solidFill>
                    <a:srgbClr val="FF0000"/>
                  </a:solidFill>
                </a:rPr>
                <a:t>Mouse</a:t>
              </a:r>
              <a:r>
                <a:rPr lang="zh-CN" altLang="en-US" sz="1200" dirty="0">
                  <a:solidFill>
                    <a:srgbClr val="FF0000"/>
                  </a:solidFill>
                </a:rPr>
                <a:t>）</a:t>
              </a:r>
            </a:p>
          </p:txBody>
        </p:sp>
      </p:grpSp>
      <p:sp>
        <p:nvSpPr>
          <p:cNvPr id="40" name="标题 1"/>
          <p:cNvSpPr>
            <a:spLocks noGrp="1"/>
          </p:cNvSpPr>
          <p:nvPr>
            <p:ph type="title"/>
          </p:nvPr>
        </p:nvSpPr>
        <p:spPr>
          <a:xfrm>
            <a:off x="-540568" y="-43179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duPIAS2 promotes DK212 NP </a:t>
            </a:r>
            <a:r>
              <a:rPr lang="en-US" altLang="zh-CN" sz="24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 by duSUMO1</a:t>
            </a:r>
            <a:endParaRPr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37010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743764" y="2225049"/>
            <a:ext cx="8117283" cy="3796239"/>
            <a:chOff x="743764" y="666398"/>
            <a:chExt cx="8117283" cy="3796239"/>
          </a:xfrm>
        </p:grpSpPr>
        <p:pic>
          <p:nvPicPr>
            <p:cNvPr id="4099" name="Picture 3" descr="C:\Users\shaopo\Desktop\PIAS NP作图\SUMO2、mu修饰NP\原图\上清myc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9872" y="1869491"/>
              <a:ext cx="2593146" cy="25931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0" name="Picture 4" descr="C:\Users\shaopo\Desktop\PIAS NP作图\SUMO2、mu修饰NP\原图\珠子NP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4208" y="1813821"/>
              <a:ext cx="2416839" cy="24168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" name="组合 6"/>
            <p:cNvGrpSpPr/>
            <p:nvPr/>
          </p:nvGrpSpPr>
          <p:grpSpPr>
            <a:xfrm>
              <a:off x="1425714" y="762360"/>
              <a:ext cx="1634118" cy="1370496"/>
              <a:chOff x="1522663" y="628551"/>
              <a:chExt cx="1634118" cy="1370496"/>
            </a:xfrm>
          </p:grpSpPr>
          <p:sp>
            <p:nvSpPr>
              <p:cNvPr id="8" name="TextBox 7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4356006" y="666398"/>
              <a:ext cx="1634118" cy="1370496"/>
              <a:chOff x="1522663" y="628551"/>
              <a:chExt cx="1634118" cy="1370496"/>
            </a:xfrm>
          </p:grpSpPr>
          <p:sp>
            <p:nvSpPr>
              <p:cNvPr id="12" name="TextBox 11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7154891" y="710974"/>
              <a:ext cx="1634118" cy="1370496"/>
              <a:chOff x="1522663" y="628551"/>
              <a:chExt cx="1634118" cy="1370496"/>
            </a:xfrm>
          </p:grpSpPr>
          <p:sp>
            <p:nvSpPr>
              <p:cNvPr id="16" name="TextBox 15"/>
              <p:cNvSpPr txBox="1"/>
              <p:nvPr/>
            </p:nvSpPr>
            <p:spPr>
              <a:xfrm rot="11838764">
                <a:off x="1522663" y="630895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</a:t>
                </a:r>
                <a:endParaRPr lang="zh-CN" altLang="en-US" sz="12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1838764">
                <a:off x="2026719" y="630894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2mu</a:t>
                </a:r>
                <a:endParaRPr lang="zh-CN" altLang="en-US" sz="12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1838764">
                <a:off x="2602783" y="628551"/>
                <a:ext cx="553998" cy="136815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200" dirty="0"/>
                  <a:t>NP+UBC9+PIAS2+SUMO1</a:t>
                </a:r>
                <a:endParaRPr lang="zh-CN" altLang="en-US" sz="1200" dirty="0"/>
              </a:p>
            </p:txBody>
          </p:sp>
        </p:grpSp>
        <p:pic>
          <p:nvPicPr>
            <p:cNvPr id="4102" name="Picture 6" descr="C:\Users\shaopo\Desktop\PIAS NP作图\SUMO2、mu修饰NP\原图\2珠子鼠HA抗体-PIAS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3764" y="2132910"/>
              <a:ext cx="2384134" cy="15146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6" name="组合 25"/>
            <p:cNvGrpSpPr/>
            <p:nvPr/>
          </p:nvGrpSpPr>
          <p:grpSpPr>
            <a:xfrm>
              <a:off x="4127845" y="3515817"/>
              <a:ext cx="1820590" cy="591031"/>
              <a:chOff x="4127845" y="3860889"/>
              <a:chExt cx="1820590" cy="591031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 err="1">
                    <a:solidFill>
                      <a:srgbClr val="FF0000"/>
                    </a:solidFill>
                  </a:rPr>
                  <a:t>Myc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7040457" y="3320937"/>
              <a:ext cx="1820590" cy="668677"/>
              <a:chOff x="1167234" y="3561983"/>
              <a:chExt cx="1820590" cy="668677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5772000" y="2780928"/>
              <a:ext cx="1063641" cy="461665"/>
              <a:chOff x="556030" y="4206279"/>
              <a:chExt cx="1063641" cy="461665"/>
            </a:xfrm>
          </p:grpSpPr>
          <p:cxnSp>
            <p:nvCxnSpPr>
              <p:cNvPr id="34" name="直接箭头连接符 33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4" name="组合 3"/>
            <p:cNvGrpSpPr/>
            <p:nvPr/>
          </p:nvGrpSpPr>
          <p:grpSpPr>
            <a:xfrm>
              <a:off x="1167234" y="3480403"/>
              <a:ext cx="1820590" cy="668677"/>
              <a:chOff x="1167234" y="3561983"/>
              <a:chExt cx="1820590" cy="668677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Rabbit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</p:grpSp>
      <p:sp>
        <p:nvSpPr>
          <p:cNvPr id="36" name="标题 1"/>
          <p:cNvSpPr>
            <a:spLocks noGrp="1"/>
          </p:cNvSpPr>
          <p:nvPr>
            <p:ph type="title"/>
          </p:nvPr>
        </p:nvSpPr>
        <p:spPr>
          <a:xfrm>
            <a:off x="-541355" y="-71222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duPIAS2 promotes DK212 NP </a:t>
            </a:r>
            <a:r>
              <a:rPr lang="en-US" altLang="zh-CN" sz="24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 by duSUMO1</a:t>
            </a:r>
            <a:endParaRPr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59444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115616" y="815962"/>
            <a:ext cx="6653136" cy="6006158"/>
            <a:chOff x="251520" y="-5333"/>
            <a:chExt cx="6969569" cy="6654230"/>
          </a:xfrm>
        </p:grpSpPr>
        <p:pic>
          <p:nvPicPr>
            <p:cNvPr id="1026" name="Picture 2" descr="C:\Users\shaopo\Desktop\祖少坡实验数据\PIAS NP作图\PIAS1，2，4对NP SUMO修饰\PIAS1，2，4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37823" y="1556792"/>
              <a:ext cx="1828601" cy="121549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矩形 3"/>
            <p:cNvSpPr/>
            <p:nvPr/>
          </p:nvSpPr>
          <p:spPr>
            <a:xfrm>
              <a:off x="1115616" y="5674796"/>
              <a:ext cx="137489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dirty="0"/>
                <a:t> </a:t>
              </a:r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2857" y="1347217"/>
              <a:ext cx="1670943" cy="23895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4" y="5288465"/>
              <a:ext cx="2505075" cy="98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3" name="Picture 9" descr="C:\Users\shaopo\Desktop\2019.1.19.2背景白.tif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0556" y="3757186"/>
              <a:ext cx="2005012" cy="1079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C:\Users\shaopo\Desktop\第一次转染样品第二次WBPIAS1，2，4对NP SUMO修饰 IP-Flag珠子HA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2857" y="4836686"/>
              <a:ext cx="1835463" cy="18122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5" name="Picture 11" descr="C:\Users\shaopo\Desktop\2019.1.20.3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5039" y="2986278"/>
              <a:ext cx="1674168" cy="2252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424" y="-5333"/>
              <a:ext cx="2581275" cy="1352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6" name="组合 15"/>
            <p:cNvGrpSpPr/>
            <p:nvPr/>
          </p:nvGrpSpPr>
          <p:grpSpPr>
            <a:xfrm>
              <a:off x="5292080" y="4495760"/>
              <a:ext cx="1820590" cy="591031"/>
              <a:chOff x="4127845" y="3860889"/>
              <a:chExt cx="1820590" cy="591031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Rabbit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5154278" y="2164538"/>
              <a:ext cx="1820590" cy="591031"/>
              <a:chOff x="4127845" y="3860889"/>
              <a:chExt cx="1820590" cy="591031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>
                    <a:solidFill>
                      <a:srgbClr val="FF0000"/>
                    </a:solidFill>
                  </a:rPr>
                  <a:t>NP 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5292080" y="5687637"/>
              <a:ext cx="1820590" cy="591031"/>
              <a:chOff x="4127845" y="3860889"/>
              <a:chExt cx="1820590" cy="591031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GAPDH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1115616" y="2818052"/>
              <a:ext cx="1820590" cy="668677"/>
              <a:chOff x="1167234" y="3561983"/>
              <a:chExt cx="1820590" cy="668677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 err="1">
                    <a:solidFill>
                      <a:srgbClr val="FF0000"/>
                    </a:solidFill>
                  </a:rPr>
                  <a:t>Myc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8" name="组合 27"/>
            <p:cNvGrpSpPr/>
            <p:nvPr/>
          </p:nvGrpSpPr>
          <p:grpSpPr>
            <a:xfrm>
              <a:off x="251520" y="4128475"/>
              <a:ext cx="1820590" cy="668677"/>
              <a:chOff x="1167234" y="3561983"/>
              <a:chExt cx="1820590" cy="668677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1" name="组合 30"/>
            <p:cNvGrpSpPr/>
            <p:nvPr/>
          </p:nvGrpSpPr>
          <p:grpSpPr>
            <a:xfrm>
              <a:off x="403920" y="5928675"/>
              <a:ext cx="1820590" cy="668677"/>
              <a:chOff x="1167234" y="3561983"/>
              <a:chExt cx="1820590" cy="668677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Rabbit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</p:grpSp>
      <p:sp>
        <p:nvSpPr>
          <p:cNvPr id="34" name="标题 1"/>
          <p:cNvSpPr>
            <a:spLocks noGrp="1"/>
          </p:cNvSpPr>
          <p:nvPr>
            <p:ph type="title"/>
          </p:nvPr>
        </p:nvSpPr>
        <p:spPr>
          <a:xfrm>
            <a:off x="-180528" y="-92560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duPIAS2 promotes DK212 NP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by duSUMO1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71454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403648" y="908720"/>
            <a:ext cx="5361625" cy="6062085"/>
            <a:chOff x="1442624" y="391249"/>
            <a:chExt cx="5361625" cy="6062085"/>
          </a:xfrm>
        </p:grpSpPr>
        <p:pic>
          <p:nvPicPr>
            <p:cNvPr id="5122" name="Picture 2" descr="C:\Users\shaopo\Desktop\NP点突变修饰\2019.8.6\220190806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776" y="4756193"/>
              <a:ext cx="4248473" cy="16971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23" name="Picture 3" descr="C:\Users\shaopo\Desktop\NP点突变修饰\2019.8.6\NP点突变20190806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0990" y="606693"/>
              <a:ext cx="4248472" cy="39851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文本框 29"/>
            <p:cNvSpPr txBox="1"/>
            <p:nvPr/>
          </p:nvSpPr>
          <p:spPr>
            <a:xfrm>
              <a:off x="2639889" y="391249"/>
              <a:ext cx="380431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</a:t>
              </a:r>
              <a:r>
                <a:rPr lang="en-US" altLang="zh-CN" sz="800" dirty="0" err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NPwt</a:t>
              </a:r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     K184R     K198R     K227R     K229R     K273R    K325R    K470R    KO</a:t>
              </a:r>
              <a:endPara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  <p:grpSp>
          <p:nvGrpSpPr>
            <p:cNvPr id="9" name="组合 8"/>
            <p:cNvGrpSpPr/>
            <p:nvPr/>
          </p:nvGrpSpPr>
          <p:grpSpPr>
            <a:xfrm>
              <a:off x="4983659" y="764704"/>
              <a:ext cx="1820590" cy="591031"/>
              <a:chOff x="4127845" y="3860889"/>
              <a:chExt cx="1820590" cy="591031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GAPDH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1708158" y="5517232"/>
              <a:ext cx="847618" cy="276999"/>
              <a:chOff x="822811" y="4298612"/>
              <a:chExt cx="847618" cy="276999"/>
            </a:xfrm>
          </p:grpSpPr>
          <p:cxnSp>
            <p:nvCxnSpPr>
              <p:cNvPr id="13" name="直接箭头连接符 12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1442624" y="2188617"/>
              <a:ext cx="1063641" cy="461665"/>
              <a:chOff x="556030" y="4206279"/>
              <a:chExt cx="1063641" cy="461665"/>
            </a:xfrm>
          </p:grpSpPr>
          <p:cxnSp>
            <p:nvCxnSpPr>
              <p:cNvPr id="16" name="直接箭头连接符 15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4765754" y="2419450"/>
              <a:ext cx="1820590" cy="668677"/>
              <a:chOff x="1167234" y="3561983"/>
              <a:chExt cx="1820590" cy="668677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1492135" y="3501008"/>
              <a:ext cx="1063641" cy="461665"/>
              <a:chOff x="556030" y="4206279"/>
              <a:chExt cx="1063641" cy="461665"/>
            </a:xfrm>
          </p:grpSpPr>
          <p:cxnSp>
            <p:nvCxnSpPr>
              <p:cNvPr id="22" name="直接箭头连接符 21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4807935" y="3777886"/>
              <a:ext cx="1820590" cy="668677"/>
              <a:chOff x="1167234" y="3561983"/>
              <a:chExt cx="1820590" cy="668677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4780532" y="5573915"/>
              <a:ext cx="1820590" cy="591031"/>
              <a:chOff x="4127845" y="3860889"/>
              <a:chExt cx="1820590" cy="591031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4572000" y="3860889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nput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127845" y="417492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1816345" y="1268760"/>
              <a:ext cx="847618" cy="276999"/>
              <a:chOff x="822811" y="4298612"/>
              <a:chExt cx="847618" cy="276999"/>
            </a:xfrm>
          </p:grpSpPr>
          <p:cxnSp>
            <p:nvCxnSpPr>
              <p:cNvPr id="31" name="直接箭头连接符 30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822811" y="4298612"/>
                <a:ext cx="8476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40KD</a:t>
                </a:r>
                <a:endParaRPr lang="zh-CN" altLang="en-US" sz="1200" dirty="0">
                  <a:solidFill>
                    <a:srgbClr val="FF0000"/>
                  </a:solidFill>
                </a:endParaRPr>
              </a:p>
            </p:txBody>
          </p:sp>
        </p:grpSp>
      </p:grpSp>
      <p:sp>
        <p:nvSpPr>
          <p:cNvPr id="33" name="标题 1"/>
          <p:cNvSpPr>
            <a:spLocks noGrp="1"/>
          </p:cNvSpPr>
          <p:nvPr>
            <p:ph type="title"/>
          </p:nvPr>
        </p:nvSpPr>
        <p:spPr>
          <a:xfrm>
            <a:off x="-180528" y="-92560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K7, K48, and K87 of DK212 NP were potential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site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08563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-20466" y="2562715"/>
            <a:ext cx="8840938" cy="4034637"/>
            <a:chOff x="-251785" y="1125322"/>
            <a:chExt cx="8840938" cy="4034637"/>
          </a:xfrm>
        </p:grpSpPr>
        <p:pic>
          <p:nvPicPr>
            <p:cNvPr id="4" name="Picture 2" descr="C:\Users\shaopo\Desktop\NP点突变修饰\NPK7-K113修饰\NP-K7-K113-IP-MYC\NP-K7-K113-K118-K470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2249" y="1340768"/>
              <a:ext cx="8136904" cy="38191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文本框 29"/>
            <p:cNvSpPr txBox="1"/>
            <p:nvPr/>
          </p:nvSpPr>
          <p:spPr>
            <a:xfrm>
              <a:off x="4784834" y="1125324"/>
              <a:ext cx="380431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</a:t>
              </a:r>
              <a:r>
                <a:rPr lang="en-US" altLang="zh-CN" sz="800" dirty="0" err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NPwt</a:t>
              </a:r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     K184R     K198R     K227R     K229R     K273R    K325R    K470R    KO</a:t>
              </a:r>
              <a:endPara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  <p:sp>
          <p:nvSpPr>
            <p:cNvPr id="6" name="文本框 29"/>
            <p:cNvSpPr txBox="1"/>
            <p:nvPr/>
          </p:nvSpPr>
          <p:spPr>
            <a:xfrm>
              <a:off x="611560" y="1125322"/>
              <a:ext cx="374441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</a:t>
              </a:r>
              <a:r>
                <a:rPr lang="en-US" altLang="zh-CN" sz="800" dirty="0" err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NPwt</a:t>
              </a:r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      K7R      K48R      K87R      K90R     K91R    K103R    K113R    KO</a:t>
              </a:r>
              <a:endPara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  <p:sp>
          <p:nvSpPr>
            <p:cNvPr id="7" name="文本框 29"/>
            <p:cNvSpPr txBox="1"/>
            <p:nvPr/>
          </p:nvSpPr>
          <p:spPr>
            <a:xfrm>
              <a:off x="4575982" y="3501008"/>
              <a:ext cx="374441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</a:t>
              </a:r>
              <a:r>
                <a:rPr lang="en-US" altLang="zh-CN" sz="800" dirty="0" err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NPwt</a:t>
              </a:r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      K7R      K48R      K87R      K90R     K91R    K103R    K113R    KO</a:t>
              </a:r>
              <a:endPara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6601027" y="2269777"/>
              <a:ext cx="1820590" cy="668677"/>
              <a:chOff x="1167234" y="3561983"/>
              <a:chExt cx="1820590" cy="668677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 err="1">
                    <a:solidFill>
                      <a:srgbClr val="FF0000"/>
                    </a:solidFill>
                  </a:rPr>
                  <a:t>Myc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2267744" y="2344491"/>
              <a:ext cx="1820590" cy="668677"/>
              <a:chOff x="1167234" y="3561983"/>
              <a:chExt cx="1820590" cy="668677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 err="1">
                    <a:solidFill>
                      <a:srgbClr val="FF0000"/>
                    </a:solidFill>
                  </a:rPr>
                  <a:t>Myc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>
              <a:off x="-35762" y="2874668"/>
              <a:ext cx="1063641" cy="461665"/>
              <a:chOff x="556030" y="4206279"/>
              <a:chExt cx="1063641" cy="461665"/>
            </a:xfrm>
          </p:grpSpPr>
          <p:cxnSp>
            <p:nvCxnSpPr>
              <p:cNvPr id="15" name="直接箭头连接符 14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17" name="组合 16"/>
            <p:cNvGrpSpPr/>
            <p:nvPr/>
          </p:nvGrpSpPr>
          <p:grpSpPr>
            <a:xfrm>
              <a:off x="-251785" y="4005064"/>
              <a:ext cx="1063641" cy="461665"/>
              <a:chOff x="556030" y="4206279"/>
              <a:chExt cx="1063641" cy="461665"/>
            </a:xfrm>
          </p:grpSpPr>
          <p:cxnSp>
            <p:nvCxnSpPr>
              <p:cNvPr id="18" name="直接箭头连接符 17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0" name="组合 19"/>
            <p:cNvGrpSpPr/>
            <p:nvPr/>
          </p:nvGrpSpPr>
          <p:grpSpPr>
            <a:xfrm>
              <a:off x="3686361" y="4300369"/>
              <a:ext cx="1063641" cy="461665"/>
              <a:chOff x="556030" y="4206279"/>
              <a:chExt cx="1063641" cy="461665"/>
            </a:xfrm>
          </p:grpSpPr>
          <p:cxnSp>
            <p:nvCxnSpPr>
              <p:cNvPr id="21" name="直接箭头连接符 20"/>
              <p:cNvCxnSpPr/>
              <p:nvPr/>
            </p:nvCxnSpPr>
            <p:spPr>
              <a:xfrm>
                <a:off x="1259803" y="4437112"/>
                <a:ext cx="3598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556030" y="4206279"/>
                <a:ext cx="8476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</a:rPr>
                  <a:t>High-chain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55KD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6542736" y="4249170"/>
              <a:ext cx="1820590" cy="668677"/>
              <a:chOff x="1167234" y="3561983"/>
              <a:chExt cx="1820590" cy="668677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HA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1866134" y="4361051"/>
              <a:ext cx="1820590" cy="668677"/>
              <a:chOff x="1167234" y="3561983"/>
              <a:chExt cx="1820590" cy="668677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1653570" y="3561983"/>
                <a:ext cx="9322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FF0000"/>
                    </a:solidFill>
                  </a:rPr>
                  <a:t>IP-Flag</a:t>
                </a:r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167234" y="3953661"/>
                <a:ext cx="1820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</a:rPr>
                  <a:t>NP antibody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（</a:t>
                </a:r>
                <a:r>
                  <a:rPr lang="en-US" altLang="zh-CN" sz="1200" dirty="0">
                    <a:solidFill>
                      <a:srgbClr val="FF0000"/>
                    </a:solidFill>
                  </a:rPr>
                  <a:t>Mouse</a:t>
                </a:r>
                <a:r>
                  <a:rPr lang="zh-CN" altLang="en-US" sz="1200" dirty="0">
                    <a:solidFill>
                      <a:srgbClr val="FF0000"/>
                    </a:solidFill>
                  </a:rPr>
                  <a:t>）</a:t>
                </a:r>
              </a:p>
            </p:txBody>
          </p:sp>
        </p:grpSp>
        <p:sp>
          <p:nvSpPr>
            <p:cNvPr id="29" name="文本框 29"/>
            <p:cNvSpPr txBox="1"/>
            <p:nvPr/>
          </p:nvSpPr>
          <p:spPr>
            <a:xfrm>
              <a:off x="480262" y="3488058"/>
              <a:ext cx="374441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</a:t>
              </a:r>
              <a:r>
                <a:rPr lang="en-US" altLang="zh-CN" sz="800" dirty="0" err="1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NPwt</a:t>
              </a:r>
              <a:r>
                <a:rPr lang="en-US" altLang="zh-CN" sz="8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  <a:sym typeface="宋体" panose="02010600030101010101" pitchFamily="2" charset="-122"/>
                </a:rPr>
                <a:t>       K7R      K48R      K87R      K90R     K91R    K103R    K113R    KO</a:t>
              </a:r>
              <a:endParaRPr lang="en-US" altLang="zh-CN" sz="8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</p:txBody>
        </p:sp>
      </p:grpSp>
      <p:sp>
        <p:nvSpPr>
          <p:cNvPr id="30" name="标题 1"/>
          <p:cNvSpPr>
            <a:spLocks noGrp="1"/>
          </p:cNvSpPr>
          <p:nvPr>
            <p:ph type="title"/>
          </p:nvPr>
        </p:nvSpPr>
        <p:spPr>
          <a:xfrm>
            <a:off x="-505780" y="404664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K7, K48, and K87 of DK212 NP were potential </a:t>
            </a:r>
            <a:r>
              <a:rPr lang="en-US" altLang="zh-CN" sz="2000" dirty="0" err="1">
                <a:latin typeface="Times New Roman" panose="02020603050405020304" charset="0"/>
                <a:cs typeface="Times New Roman" panose="02020603050405020304" charset="0"/>
              </a:rPr>
              <a:t>SUMOylation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site</a:t>
            </a:r>
            <a:endParaRPr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756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1</Words>
  <Application>Microsoft Office PowerPoint</Application>
  <PresentationFormat>On-screen Show (4:3)</PresentationFormat>
  <Paragraphs>230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Times New Roman</vt:lpstr>
      <vt:lpstr>Office 主题</vt:lpstr>
      <vt:lpstr>duPIAS2 interacts with DK212 NP</vt:lpstr>
      <vt:lpstr>duPIAS2 promotes DK212 NP SUMOylation by SUMO1</vt:lpstr>
      <vt:lpstr>duPIAS2 promotes DK212 NP SUMOylation by duSUMO1</vt:lpstr>
      <vt:lpstr>duPIAS2 promotes DK212 NP SUMOylation by duSUMO1</vt:lpstr>
      <vt:lpstr>duPIAS2 promotes DK212 NP SUMOylation by duSUMO1</vt:lpstr>
      <vt:lpstr>duPIAS2 promotes DK212 NP SUMOylation by duSUMO1</vt:lpstr>
      <vt:lpstr>duPIAS2 promotes DK212 NP SUMOylation by duSUMO1</vt:lpstr>
      <vt:lpstr>K7, K48, and K87 of DK212 NP were potential SUMOylation site</vt:lpstr>
      <vt:lpstr>K7, K48, and K87 of DK212 NP were potential SUMOylation site</vt:lpstr>
      <vt:lpstr>K7, K48, and K87 of DK212 NP were potential SUMOylation site</vt:lpstr>
      <vt:lpstr>K7, K48, and K87 of DK212 NP were potential SUMOylation site</vt:lpstr>
      <vt:lpstr>K7, K48, and K87 of DK212 NP were potential SUMOylation site</vt:lpstr>
      <vt:lpstr>duSENP1 inhibited the SUMOylation of DK212 NP promoted by duPIAS2</vt:lpstr>
      <vt:lpstr>duSENP1 inhibited the SUMOylation of DK212 NP promoted by duPIAS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原始数据图片</dc:title>
  <dc:creator>shaopo</dc:creator>
  <cp:lastModifiedBy>Anisa Fazal</cp:lastModifiedBy>
  <cp:revision>34</cp:revision>
  <dcterms:created xsi:type="dcterms:W3CDTF">2019-08-29T13:43:17Z</dcterms:created>
  <dcterms:modified xsi:type="dcterms:W3CDTF">2020-06-05T13:26:27Z</dcterms:modified>
</cp:coreProperties>
</file>